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93AD1-2EBA-4000-B6D3-184D8E8376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A7714-3E9D-4C25-8DE8-04815B7F27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E3119E-6BF5-497D-9B4F-58EF620316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D533E-1D92-4E54-ACCD-212D05F61E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E3E4C-034F-4CED-8A12-DFC5E381D3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C9B30-FF6C-4E2A-9E82-E4245F2736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35F90-77E3-4C45-BDD4-2D0EB3E742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6FFFE2-C055-4D21-9984-AC4B5297DC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8E0D6-5BEA-4DBF-B698-44AB3A28E8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63D558-D90A-467E-BD15-A18392D3CB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BF0471-ACE3-4D6C-99A2-4FAE8C3503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F1C33-8128-48DB-A174-315A8F8C98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ED639F-21D6-4C37-ACF4-95C5D99E6A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3524400" y="3960720"/>
            <a:ext cx="1353960" cy="795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2" name="Rectangle 5"/>
          <p:cNvSpPr/>
          <p:nvPr/>
        </p:nvSpPr>
        <p:spPr>
          <a:xfrm>
            <a:off x="3506400" y="4981680"/>
            <a:ext cx="68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dCM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"/>
          <p:cNvSpPr/>
          <p:nvPr/>
        </p:nvSpPr>
        <p:spPr>
          <a:xfrm>
            <a:off x="4118040" y="4981680"/>
            <a:ext cx="87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dWISP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7"/>
          <p:cNvSpPr/>
          <p:nvPr/>
        </p:nvSpPr>
        <p:spPr>
          <a:xfrm>
            <a:off x="3431520" y="47782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8"/>
          <p:cNvSpPr/>
          <p:nvPr/>
        </p:nvSpPr>
        <p:spPr>
          <a:xfrm>
            <a:off x="3787200" y="47782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9"/>
          <p:cNvSpPr/>
          <p:nvPr/>
        </p:nvSpPr>
        <p:spPr>
          <a:xfrm>
            <a:off x="4114440" y="47782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0"/>
          <p:cNvSpPr/>
          <p:nvPr/>
        </p:nvSpPr>
        <p:spPr>
          <a:xfrm>
            <a:off x="4473000" y="47782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1"/>
          <p:cNvSpPr/>
          <p:nvPr/>
        </p:nvSpPr>
        <p:spPr>
          <a:xfrm>
            <a:off x="3524400" y="4971960"/>
            <a:ext cx="64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2"/>
          <p:cNvSpPr/>
          <p:nvPr/>
        </p:nvSpPr>
        <p:spPr>
          <a:xfrm>
            <a:off x="4219560" y="4971960"/>
            <a:ext cx="649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3"/>
          <p:cNvSpPr/>
          <p:nvPr/>
        </p:nvSpPr>
        <p:spPr>
          <a:xfrm>
            <a:off x="5334120" y="8610480"/>
            <a:ext cx="121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 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8"/>
          <p:cNvSpPr/>
          <p:nvPr/>
        </p:nvSpPr>
        <p:spPr>
          <a:xfrm>
            <a:off x="1144080" y="312408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9"/>
          <p:cNvSpPr/>
          <p:nvPr/>
        </p:nvSpPr>
        <p:spPr>
          <a:xfrm>
            <a:off x="3260520" y="312408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2"/>
          <p:cNvSpPr/>
          <p:nvPr/>
        </p:nvSpPr>
        <p:spPr>
          <a:xfrm>
            <a:off x="4962240" y="4772160"/>
            <a:ext cx="96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particles/cel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6"/>
          <p:cNvSpPr/>
          <p:nvPr/>
        </p:nvSpPr>
        <p:spPr>
          <a:xfrm>
            <a:off x="1833120" y="5608800"/>
            <a:ext cx="119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00 particles/cel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27"/>
          <p:cNvSpPr/>
          <p:nvPr/>
        </p:nvSpPr>
        <p:spPr>
          <a:xfrm>
            <a:off x="1905120" y="5626080"/>
            <a:ext cx="1119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図形グループ 45"/>
          <p:cNvGrpSpPr/>
          <p:nvPr/>
        </p:nvGrpSpPr>
        <p:grpSpPr>
          <a:xfrm>
            <a:off x="981000" y="3317760"/>
            <a:ext cx="2019240" cy="2306880"/>
            <a:chOff x="981000" y="3317760"/>
            <a:chExt cx="2019240" cy="2306880"/>
          </a:xfrm>
        </p:grpSpPr>
        <p:sp>
          <p:nvSpPr>
            <p:cNvPr id="57" name="直線コネクタ 18"/>
            <p:cNvSpPr/>
            <p:nvPr/>
          </p:nvSpPr>
          <p:spPr>
            <a:xfrm flipH="1" flipV="1">
              <a:off x="1882080" y="5059080"/>
              <a:ext cx="1118160" cy="1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直線コネクタ 19"/>
            <p:cNvSpPr/>
            <p:nvPr/>
          </p:nvSpPr>
          <p:spPr>
            <a:xfrm flipH="1">
              <a:off x="1888920" y="3450240"/>
              <a:ext cx="1800" cy="1615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テキスト ボックス 20"/>
            <p:cNvSpPr/>
            <p:nvPr/>
          </p:nvSpPr>
          <p:spPr>
            <a:xfrm>
              <a:off x="1477800" y="438300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テキスト ボックス 21"/>
            <p:cNvSpPr/>
            <p:nvPr/>
          </p:nvSpPr>
          <p:spPr>
            <a:xfrm>
              <a:off x="1574640" y="4922640"/>
              <a:ext cx="32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直線コネクタ 22"/>
            <p:cNvSpPr/>
            <p:nvPr/>
          </p:nvSpPr>
          <p:spPr>
            <a:xfrm flipH="1" flipV="1">
              <a:off x="1837440" y="4537800"/>
              <a:ext cx="507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テキスト ボックス 23"/>
            <p:cNvSpPr/>
            <p:nvPr/>
          </p:nvSpPr>
          <p:spPr>
            <a:xfrm>
              <a:off x="1477800" y="386712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直線コネクタ 24"/>
            <p:cNvSpPr/>
            <p:nvPr/>
          </p:nvSpPr>
          <p:spPr>
            <a:xfrm flipH="1" flipV="1">
              <a:off x="1833840" y="4014360"/>
              <a:ext cx="507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テキスト ボックス 25"/>
            <p:cNvSpPr/>
            <p:nvPr/>
          </p:nvSpPr>
          <p:spPr>
            <a:xfrm>
              <a:off x="1477800" y="331776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直線コネクタ 26"/>
            <p:cNvSpPr/>
            <p:nvPr/>
          </p:nvSpPr>
          <p:spPr>
            <a:xfrm flipH="1" flipV="1">
              <a:off x="1833840" y="3471480"/>
              <a:ext cx="507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テキスト ボックス 27"/>
            <p:cNvSpPr/>
            <p:nvPr/>
          </p:nvSpPr>
          <p:spPr>
            <a:xfrm>
              <a:off x="981000" y="5135400"/>
              <a:ext cx="850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dCM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テキスト ボックス 28"/>
            <p:cNvSpPr/>
            <p:nvPr/>
          </p:nvSpPr>
          <p:spPr>
            <a:xfrm>
              <a:off x="981000" y="5348160"/>
              <a:ext cx="1081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dWISP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テキスト ボックス 29"/>
            <p:cNvSpPr/>
            <p:nvPr/>
          </p:nvSpPr>
          <p:spPr>
            <a:xfrm>
              <a:off x="1965240" y="5099040"/>
              <a:ext cx="353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テキスト ボックス 30"/>
            <p:cNvSpPr/>
            <p:nvPr/>
          </p:nvSpPr>
          <p:spPr>
            <a:xfrm>
              <a:off x="2523960" y="5311800"/>
              <a:ext cx="353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テキスト ボックス 31"/>
            <p:cNvSpPr/>
            <p:nvPr/>
          </p:nvSpPr>
          <p:spPr>
            <a:xfrm>
              <a:off x="2546280" y="5060880"/>
              <a:ext cx="309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テキスト ボックス 32"/>
            <p:cNvSpPr/>
            <p:nvPr/>
          </p:nvSpPr>
          <p:spPr>
            <a:xfrm>
              <a:off x="1989000" y="5275440"/>
              <a:ext cx="307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正方形/長方形 33"/>
            <p:cNvSpPr/>
            <p:nvPr/>
          </p:nvSpPr>
          <p:spPr>
            <a:xfrm>
              <a:off x="1961640" y="4951080"/>
              <a:ext cx="361440" cy="10080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3" name="図形グループ 34"/>
            <p:cNvGrpSpPr/>
            <p:nvPr/>
          </p:nvGrpSpPr>
          <p:grpSpPr>
            <a:xfrm>
              <a:off x="2050200" y="4921920"/>
              <a:ext cx="185760" cy="48240"/>
              <a:chOff x="2050200" y="4921920"/>
              <a:chExt cx="185760" cy="48240"/>
            </a:xfrm>
          </p:grpSpPr>
          <p:sp>
            <p:nvSpPr>
              <p:cNvPr id="74" name="直線コネクタ 35"/>
              <p:cNvSpPr/>
              <p:nvPr/>
            </p:nvSpPr>
            <p:spPr>
              <a:xfrm flipH="1">
                <a:off x="2143800" y="4921920"/>
                <a:ext cx="1800" cy="48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" bIns="1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直線コネクタ 36"/>
              <p:cNvSpPr/>
              <p:nvPr/>
            </p:nvSpPr>
            <p:spPr>
              <a:xfrm>
                <a:off x="2050200" y="4921920"/>
                <a:ext cx="185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6" name="テキスト ボックス 37"/>
            <p:cNvSpPr/>
            <p:nvPr/>
          </p:nvSpPr>
          <p:spPr>
            <a:xfrm>
              <a:off x="2479680" y="3323880"/>
              <a:ext cx="444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7" name="図形グループ 38"/>
            <p:cNvGrpSpPr/>
            <p:nvPr/>
          </p:nvGrpSpPr>
          <p:grpSpPr>
            <a:xfrm>
              <a:off x="2608200" y="3626280"/>
              <a:ext cx="185760" cy="91440"/>
              <a:chOff x="2608200" y="3626280"/>
              <a:chExt cx="185760" cy="91440"/>
            </a:xfrm>
          </p:grpSpPr>
          <p:sp>
            <p:nvSpPr>
              <p:cNvPr id="78" name="直線コネクタ 39"/>
              <p:cNvSpPr/>
              <p:nvPr/>
            </p:nvSpPr>
            <p:spPr>
              <a:xfrm flipH="1">
                <a:off x="2702160" y="3626280"/>
                <a:ext cx="1800" cy="9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640" bIns="44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直線コネクタ 40"/>
              <p:cNvSpPr/>
              <p:nvPr/>
            </p:nvSpPr>
            <p:spPr>
              <a:xfrm>
                <a:off x="2608200" y="3626280"/>
                <a:ext cx="18576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0" name="正方形/長方形 41"/>
            <p:cNvSpPr/>
            <p:nvPr/>
          </p:nvSpPr>
          <p:spPr>
            <a:xfrm>
              <a:off x="2520360" y="3666960"/>
              <a:ext cx="361440" cy="13831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テキスト ボックス 43"/>
            <p:cNvSpPr/>
            <p:nvPr/>
          </p:nvSpPr>
          <p:spPr>
            <a:xfrm rot="16200000">
              <a:off x="695160" y="4029840"/>
              <a:ext cx="1325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</a:rPr>
                <a:t>WISP-1/S2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"/>
          <p:cNvSpPr/>
          <p:nvPr/>
        </p:nvSpPr>
        <p:spPr>
          <a:xfrm>
            <a:off x="762120" y="6477120"/>
            <a:ext cx="5163840" cy="137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S1. Over-expression of WISP-1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A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 Real-time PCR showing relative levels of WISP-1 mRNA in hBMSC transduced with adWISP-1 ***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&lt;0.001 adCMV vs. adWISP-1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B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Western blot showing WISP-1 protein production in adCMV or adWISP-1 transduced hBMSCs.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MS Mincho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5T07:46:00Z</dcterms:created>
  <dc:creator>Mitsuaki Ono</dc:creator>
  <dc:description/>
  <dc:language>en-US</dc:language>
  <cp:lastModifiedBy>Marian Young</cp:lastModifiedBy>
  <cp:lastPrinted>2010-02-04T00:54:04Z</cp:lastPrinted>
  <dcterms:modified xsi:type="dcterms:W3CDTF">2010-06-15T19:13:04Z</dcterms:modified>
  <cp:revision>398</cp:revision>
  <dc:subject/>
  <dc:title>PowerPoint Presentation</dc:title>
</cp:coreProperties>
</file>